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DBB28-5201-46A7-944E-9C35DDBFF8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92F55-5E73-4632-9026-1CA22365C7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BF9FC-4792-4C4B-8BAF-863230768F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7B3D0-DAD6-4F9F-BF14-AC5BB517A7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4F398-AE0F-4897-9999-5C395A94D6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35BB8-22AE-4331-8820-152F65574C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D0203-F8B0-4C11-9AD6-32AC0B721D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17BFE-39AE-49D6-A4ED-A6AABF2B91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BD2F5-0BEC-4967-BE2A-C0C5DDADF0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F4D1D-CAAF-49E0-B6F3-06BCA294B5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BB623-2FF1-4E79-82FF-5F2783787B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4480E-9254-48EA-AD5D-4FA6489153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72BBE1-FC10-4D82-9812-0D886081FC6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1" descr=""/>
          <p:cNvPicPr/>
          <p:nvPr/>
        </p:nvPicPr>
        <p:blipFill>
          <a:blip r:embed="rId1"/>
          <a:stretch/>
        </p:blipFill>
        <p:spPr>
          <a:xfrm>
            <a:off x="4581360" y="2914560"/>
            <a:ext cx="2073600" cy="19447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9" descr=""/>
          <p:cNvPicPr/>
          <p:nvPr/>
        </p:nvPicPr>
        <p:blipFill>
          <a:blip r:embed="rId2"/>
          <a:stretch/>
        </p:blipFill>
        <p:spPr>
          <a:xfrm>
            <a:off x="2421000" y="2916360"/>
            <a:ext cx="2073240" cy="1944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0" descr=""/>
          <p:cNvPicPr/>
          <p:nvPr/>
        </p:nvPicPr>
        <p:blipFill>
          <a:blip r:embed="rId3"/>
          <a:stretch/>
        </p:blipFill>
        <p:spPr>
          <a:xfrm>
            <a:off x="276120" y="2914560"/>
            <a:ext cx="2073240" cy="19447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8" descr=""/>
          <p:cNvPicPr/>
          <p:nvPr/>
        </p:nvPicPr>
        <p:blipFill>
          <a:blip r:embed="rId4"/>
          <a:stretch/>
        </p:blipFill>
        <p:spPr>
          <a:xfrm>
            <a:off x="4413240" y="324000"/>
            <a:ext cx="1536840" cy="14396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7" descr=""/>
          <p:cNvPicPr/>
          <p:nvPr/>
        </p:nvPicPr>
        <p:blipFill>
          <a:blip r:embed="rId5"/>
          <a:stretch/>
        </p:blipFill>
        <p:spPr>
          <a:xfrm>
            <a:off x="2924280" y="324000"/>
            <a:ext cx="1512720" cy="14173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45" descr=""/>
          <p:cNvPicPr/>
          <p:nvPr/>
        </p:nvPicPr>
        <p:blipFill>
          <a:blip r:embed="rId6"/>
          <a:stretch/>
        </p:blipFill>
        <p:spPr>
          <a:xfrm>
            <a:off x="333360" y="324000"/>
            <a:ext cx="2158920" cy="202536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3"/>
          <p:cNvSpPr/>
          <p:nvPr/>
        </p:nvSpPr>
        <p:spPr>
          <a:xfrm>
            <a:off x="7560" y="883116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39"/>
          <p:cNvSpPr/>
          <p:nvPr/>
        </p:nvSpPr>
        <p:spPr>
          <a:xfrm>
            <a:off x="2708280" y="-36360"/>
            <a:ext cx="25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9"/>
          <p:cNvSpPr/>
          <p:nvPr/>
        </p:nvSpPr>
        <p:spPr>
          <a:xfrm>
            <a:off x="2933640" y="1619280"/>
            <a:ext cx="3270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(month) from sample don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50"/>
          <p:cNvSpPr/>
          <p:nvPr/>
        </p:nvSpPr>
        <p:spPr>
          <a:xfrm>
            <a:off x="3743280" y="1739880"/>
            <a:ext cx="166212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tratified log rank t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= 0.0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HR = 2.7 (1.0 - 7.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51"/>
          <p:cNvSpPr/>
          <p:nvPr/>
        </p:nvSpPr>
        <p:spPr>
          <a:xfrm>
            <a:off x="3790800" y="527040"/>
            <a:ext cx="644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LINE-1 </a:t>
            </a:r>
            <a:r>
              <a:rPr b="0" lang="ja-JP" sz="6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36.0%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52"/>
          <p:cNvSpPr/>
          <p:nvPr/>
        </p:nvSpPr>
        <p:spPr>
          <a:xfrm>
            <a:off x="3791880" y="770040"/>
            <a:ext cx="637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LINE-1 &lt; 36.0%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53"/>
          <p:cNvSpPr/>
          <p:nvPr/>
        </p:nvSpPr>
        <p:spPr>
          <a:xfrm>
            <a:off x="5311800" y="534960"/>
            <a:ext cx="644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LINE-1 </a:t>
            </a:r>
            <a:r>
              <a:rPr b="0" lang="ja-JP" sz="6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36.0%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54"/>
          <p:cNvSpPr/>
          <p:nvPr/>
        </p:nvSpPr>
        <p:spPr>
          <a:xfrm>
            <a:off x="5103720" y="1000080"/>
            <a:ext cx="637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LINE-1 &lt; 36.0%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14"/>
          <p:cNvSpPr/>
          <p:nvPr/>
        </p:nvSpPr>
        <p:spPr>
          <a:xfrm>
            <a:off x="3455640" y="158760"/>
            <a:ext cx="65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3q intac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15"/>
          <p:cNvSpPr/>
          <p:nvPr/>
        </p:nvSpPr>
        <p:spPr>
          <a:xfrm>
            <a:off x="4893480" y="168120"/>
            <a:ext cx="74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3q delet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16"/>
          <p:cNvSpPr/>
          <p:nvPr/>
        </p:nvSpPr>
        <p:spPr>
          <a:xfrm rot="16200000">
            <a:off x="2509200" y="762120"/>
            <a:ext cx="88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urvival propor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3"/>
          <p:cNvSpPr/>
          <p:nvPr/>
        </p:nvSpPr>
        <p:spPr>
          <a:xfrm>
            <a:off x="1060560" y="268452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lu Yb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3"/>
          <p:cNvSpPr/>
          <p:nvPr/>
        </p:nvSpPr>
        <p:spPr>
          <a:xfrm>
            <a:off x="3221640" y="2684520"/>
            <a:ext cx="7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lu Ya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9"/>
          <p:cNvSpPr/>
          <p:nvPr/>
        </p:nvSpPr>
        <p:spPr>
          <a:xfrm>
            <a:off x="5456160" y="2684520"/>
            <a:ext cx="56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at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9"/>
          <p:cNvSpPr/>
          <p:nvPr/>
        </p:nvSpPr>
        <p:spPr>
          <a:xfrm>
            <a:off x="946080" y="4702320"/>
            <a:ext cx="4897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(months) from diagno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70"/>
          <p:cNvSpPr/>
          <p:nvPr/>
        </p:nvSpPr>
        <p:spPr>
          <a:xfrm rot="16200000">
            <a:off x="-399960" y="3539520"/>
            <a:ext cx="134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rvival propor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71"/>
          <p:cNvSpPr/>
          <p:nvPr/>
        </p:nvSpPr>
        <p:spPr>
          <a:xfrm>
            <a:off x="1676520" y="3306600"/>
            <a:ext cx="601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9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73.5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72"/>
          <p:cNvSpPr/>
          <p:nvPr/>
        </p:nvSpPr>
        <p:spPr>
          <a:xfrm>
            <a:off x="1491480" y="3624120"/>
            <a:ext cx="60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&lt; 73.5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73"/>
          <p:cNvSpPr/>
          <p:nvPr/>
        </p:nvSpPr>
        <p:spPr>
          <a:xfrm>
            <a:off x="562680" y="4137120"/>
            <a:ext cx="158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og rank test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 0.2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15"/>
          <p:cNvSpPr/>
          <p:nvPr/>
        </p:nvSpPr>
        <p:spPr>
          <a:xfrm>
            <a:off x="554760" y="4260960"/>
            <a:ext cx="1389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R = 1.6 (0.7</a:t>
            </a:r>
            <a:r>
              <a:rPr b="1" lang="ja-JP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3.5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75"/>
          <p:cNvSpPr/>
          <p:nvPr/>
        </p:nvSpPr>
        <p:spPr>
          <a:xfrm>
            <a:off x="2729880" y="4137120"/>
            <a:ext cx="155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og rank test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 0.0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17"/>
          <p:cNvSpPr/>
          <p:nvPr/>
        </p:nvSpPr>
        <p:spPr>
          <a:xfrm>
            <a:off x="2721600" y="4260960"/>
            <a:ext cx="1389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R = 2.2 (1.0 - 5.0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77"/>
          <p:cNvSpPr/>
          <p:nvPr/>
        </p:nvSpPr>
        <p:spPr>
          <a:xfrm>
            <a:off x="4890600" y="4137120"/>
            <a:ext cx="155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og rank test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 0.2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19"/>
          <p:cNvSpPr/>
          <p:nvPr/>
        </p:nvSpPr>
        <p:spPr>
          <a:xfrm>
            <a:off x="4882320" y="4260960"/>
            <a:ext cx="1389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R = 1.7 (0.7 - 3.9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79"/>
          <p:cNvSpPr/>
          <p:nvPr/>
        </p:nvSpPr>
        <p:spPr>
          <a:xfrm>
            <a:off x="3836880" y="3262320"/>
            <a:ext cx="601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9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33.4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80"/>
          <p:cNvSpPr/>
          <p:nvPr/>
        </p:nvSpPr>
        <p:spPr>
          <a:xfrm>
            <a:off x="3580920" y="3691080"/>
            <a:ext cx="60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&lt; 33.4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81"/>
          <p:cNvSpPr/>
          <p:nvPr/>
        </p:nvSpPr>
        <p:spPr>
          <a:xfrm>
            <a:off x="6100920" y="3306600"/>
            <a:ext cx="601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9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7.5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82"/>
          <p:cNvSpPr/>
          <p:nvPr/>
        </p:nvSpPr>
        <p:spPr>
          <a:xfrm>
            <a:off x="5812920" y="3624120"/>
            <a:ext cx="605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&lt; 27.5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64"/>
          <p:cNvSpPr/>
          <p:nvPr/>
        </p:nvSpPr>
        <p:spPr>
          <a:xfrm>
            <a:off x="111240" y="2484360"/>
            <a:ext cx="258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82"/>
          <p:cNvSpPr/>
          <p:nvPr/>
        </p:nvSpPr>
        <p:spPr>
          <a:xfrm>
            <a:off x="146160" y="-36360"/>
            <a:ext cx="258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17"/>
          <p:cNvSpPr/>
          <p:nvPr/>
        </p:nvSpPr>
        <p:spPr>
          <a:xfrm rot="16200000">
            <a:off x="-212760" y="1112400"/>
            <a:ext cx="123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rvival propor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91"/>
          <p:cNvSpPr/>
          <p:nvPr/>
        </p:nvSpPr>
        <p:spPr>
          <a:xfrm>
            <a:off x="1570680" y="541440"/>
            <a:ext cx="806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LINE-1 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36.0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92"/>
          <p:cNvSpPr/>
          <p:nvPr/>
        </p:nvSpPr>
        <p:spPr>
          <a:xfrm>
            <a:off x="1562760" y="1541520"/>
            <a:ext cx="810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LINE-1 &lt; 36.0%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93"/>
          <p:cNvSpPr/>
          <p:nvPr/>
        </p:nvSpPr>
        <p:spPr>
          <a:xfrm>
            <a:off x="681480" y="1719360"/>
            <a:ext cx="131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og rank test 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= 0.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44"/>
          <p:cNvSpPr/>
          <p:nvPr/>
        </p:nvSpPr>
        <p:spPr>
          <a:xfrm>
            <a:off x="682200" y="1824120"/>
            <a:ext cx="126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R = 2.8 (1.2 - 6.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9"/>
          <p:cNvSpPr/>
          <p:nvPr/>
        </p:nvSpPr>
        <p:spPr>
          <a:xfrm>
            <a:off x="731880" y="2143080"/>
            <a:ext cx="160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(month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rom diagno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1:53:55Z</dcterms:created>
  <dc:creator>MN2010</dc:creator>
  <dc:description/>
  <dc:language>en-US</dc:language>
  <cp:lastModifiedBy>MN2010</cp:lastModifiedBy>
  <dcterms:modified xsi:type="dcterms:W3CDTF">2012-12-14T01:22:40Z</dcterms:modified>
  <cp:revision>1158</cp:revision>
  <dc:subject/>
  <dc:title>スライド 1</dc:title>
</cp:coreProperties>
</file>